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BF979-36D4-4264-8A0F-843EB739AB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788688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302360"/>
            <a:ext cx="788688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EB117-0648-4C3D-8644-3043C3615B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30236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30236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2C2469-F29A-400F-98C4-87F48B2F17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91592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91592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30236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30236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302360"/>
            <a:ext cx="253944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029FE-517A-43A7-A22E-A0467BC1A2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915920"/>
            <a:ext cx="7886880" cy="456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358A5-BEA2-4069-AAF9-3FAB24AC9B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788688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D7A9D-ADB7-4E7B-9A97-E034D0A4F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384876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915920"/>
            <a:ext cx="384876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9A3B1-D4E7-4067-9714-3D7759C9C8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B9F96-60D8-44DE-BCA4-8282D74C8F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82320"/>
            <a:ext cx="7886880" cy="645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E0C1C-347F-4989-B537-D1126F13CD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915920"/>
            <a:ext cx="384876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30236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3B9C1-8180-4A80-88DF-31405D5344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384876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30236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A6C54-063D-485A-B7AA-D93C478CA9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915920"/>
            <a:ext cx="384876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302360"/>
            <a:ext cx="7886880" cy="2179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52DDE-E7F7-4075-8FFC-D7B78FE1AB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82320"/>
            <a:ext cx="7886880" cy="13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915920"/>
            <a:ext cx="7886880" cy="456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671880"/>
            <a:ext cx="205740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671880"/>
            <a:ext cx="308592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671880"/>
            <a:ext cx="2057400" cy="384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zh-CN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356590-82CB-4063-8825-DC0D6D2D4D6A}" type="slidenum">
              <a:rPr b="1" lang="zh-CN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2"/>
          <p:cNvSpPr/>
          <p:nvPr/>
        </p:nvSpPr>
        <p:spPr>
          <a:xfrm>
            <a:off x="828720" y="1147680"/>
            <a:ext cx="1915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pET28a/Msr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60"/>
          <p:cNvSpPr/>
          <p:nvPr/>
        </p:nvSpPr>
        <p:spPr>
          <a:xfrm>
            <a:off x="828720" y="3110040"/>
            <a:ext cx="282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pET28a/PEP-1-Msr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组合 7"/>
          <p:cNvGrpSpPr/>
          <p:nvPr/>
        </p:nvGrpSpPr>
        <p:grpSpPr>
          <a:xfrm>
            <a:off x="108000" y="3679920"/>
            <a:ext cx="8891640" cy="712080"/>
            <a:chOff x="108000" y="3679920"/>
            <a:chExt cx="8891640" cy="712080"/>
          </a:xfrm>
        </p:grpSpPr>
        <p:sp>
          <p:nvSpPr>
            <p:cNvPr id="44" name="矩形 50"/>
            <p:cNvSpPr/>
            <p:nvPr/>
          </p:nvSpPr>
          <p:spPr>
            <a:xfrm>
              <a:off x="3682080" y="3822840"/>
              <a:ext cx="873000" cy="43128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文本框 73"/>
            <p:cNvSpPr/>
            <p:nvPr/>
          </p:nvSpPr>
          <p:spPr>
            <a:xfrm>
              <a:off x="3813840" y="3915000"/>
              <a:ext cx="741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PEP-1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直接连接符 42"/>
            <p:cNvSpPr/>
            <p:nvPr/>
          </p:nvSpPr>
          <p:spPr>
            <a:xfrm>
              <a:off x="3339000" y="4034520"/>
              <a:ext cx="331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右箭头 1"/>
            <p:cNvSpPr/>
            <p:nvPr/>
          </p:nvSpPr>
          <p:spPr>
            <a:xfrm>
              <a:off x="108000" y="3679920"/>
              <a:ext cx="1311840" cy="712080"/>
            </a:xfrm>
            <a:prstGeom prst="rightArrow">
              <a:avLst>
                <a:gd name="adj1" fmla="val 50000"/>
                <a:gd name="adj2" fmla="val 55754"/>
              </a:avLst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矩形 3"/>
            <p:cNvSpPr/>
            <p:nvPr/>
          </p:nvSpPr>
          <p:spPr>
            <a:xfrm>
              <a:off x="1766520" y="3808440"/>
              <a:ext cx="731880" cy="43632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接连接符 5"/>
            <p:cNvSpPr/>
            <p:nvPr/>
          </p:nvSpPr>
          <p:spPr>
            <a:xfrm>
              <a:off x="1434960" y="4024440"/>
              <a:ext cx="331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接连接符 37"/>
            <p:cNvSpPr/>
            <p:nvPr/>
          </p:nvSpPr>
          <p:spPr>
            <a:xfrm>
              <a:off x="2480040" y="4012200"/>
              <a:ext cx="331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矩形 38"/>
            <p:cNvSpPr/>
            <p:nvPr/>
          </p:nvSpPr>
          <p:spPr>
            <a:xfrm>
              <a:off x="2798280" y="3814200"/>
              <a:ext cx="548640" cy="4320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矩形 39"/>
            <p:cNvSpPr/>
            <p:nvPr/>
          </p:nvSpPr>
          <p:spPr>
            <a:xfrm>
              <a:off x="5553720" y="3812760"/>
              <a:ext cx="1781280" cy="4320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矩形 40"/>
            <p:cNvSpPr/>
            <p:nvPr/>
          </p:nvSpPr>
          <p:spPr>
            <a:xfrm>
              <a:off x="7656480" y="3822120"/>
              <a:ext cx="646920" cy="4320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41"/>
            <p:cNvSpPr/>
            <p:nvPr/>
          </p:nvSpPr>
          <p:spPr>
            <a:xfrm>
              <a:off x="7335360" y="4038480"/>
              <a:ext cx="331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接连接符 42"/>
            <p:cNvSpPr/>
            <p:nvPr/>
          </p:nvSpPr>
          <p:spPr>
            <a:xfrm>
              <a:off x="4555440" y="4032360"/>
              <a:ext cx="19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矩形 43"/>
            <p:cNvSpPr/>
            <p:nvPr/>
          </p:nvSpPr>
          <p:spPr>
            <a:xfrm>
              <a:off x="8499600" y="3826080"/>
              <a:ext cx="496800" cy="4320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文本框 6"/>
            <p:cNvSpPr/>
            <p:nvPr/>
          </p:nvSpPr>
          <p:spPr>
            <a:xfrm>
              <a:off x="113400" y="3908880"/>
              <a:ext cx="118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T7 promoter 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文本框 63"/>
            <p:cNvSpPr/>
            <p:nvPr/>
          </p:nvSpPr>
          <p:spPr>
            <a:xfrm>
              <a:off x="1789200" y="3908880"/>
              <a:ext cx="743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6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× His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文本框 65"/>
            <p:cNvSpPr/>
            <p:nvPr/>
          </p:nvSpPr>
          <p:spPr>
            <a:xfrm>
              <a:off x="2824560" y="3905280"/>
              <a:ext cx="61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Nde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 </a:t>
              </a:r>
              <a:r>
                <a:rPr b="0" lang="az-Cyrl-AZ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І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文本框 68"/>
            <p:cNvSpPr/>
            <p:nvPr/>
          </p:nvSpPr>
          <p:spPr>
            <a:xfrm>
              <a:off x="6172920" y="3922920"/>
              <a:ext cx="862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MsrA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文本框 69"/>
            <p:cNvSpPr/>
            <p:nvPr/>
          </p:nvSpPr>
          <p:spPr>
            <a:xfrm>
              <a:off x="7656480" y="3905280"/>
              <a:ext cx="70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Hind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III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文本框 71"/>
            <p:cNvSpPr/>
            <p:nvPr/>
          </p:nvSpPr>
          <p:spPr>
            <a:xfrm>
              <a:off x="8539920" y="3893400"/>
              <a:ext cx="45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End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文本框 65"/>
            <p:cNvSpPr/>
            <p:nvPr/>
          </p:nvSpPr>
          <p:spPr>
            <a:xfrm>
              <a:off x="4754160" y="3908880"/>
              <a:ext cx="730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BamH</a:t>
              </a:r>
              <a:r>
                <a:rPr b="0" lang="az-Cyrl-AZ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І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矩形 38"/>
            <p:cNvSpPr/>
            <p:nvPr/>
          </p:nvSpPr>
          <p:spPr>
            <a:xfrm>
              <a:off x="4765320" y="3826080"/>
              <a:ext cx="608040" cy="4244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接连接符 42"/>
            <p:cNvSpPr/>
            <p:nvPr/>
          </p:nvSpPr>
          <p:spPr>
            <a:xfrm>
              <a:off x="5369760" y="4032360"/>
              <a:ext cx="19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接连接符 42"/>
            <p:cNvSpPr/>
            <p:nvPr/>
          </p:nvSpPr>
          <p:spPr>
            <a:xfrm>
              <a:off x="8299080" y="4032360"/>
              <a:ext cx="19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组合 8"/>
          <p:cNvGrpSpPr/>
          <p:nvPr/>
        </p:nvGrpSpPr>
        <p:grpSpPr>
          <a:xfrm>
            <a:off x="755640" y="1727280"/>
            <a:ext cx="7056360" cy="712800"/>
            <a:chOff x="755640" y="1727280"/>
            <a:chExt cx="7056360" cy="712800"/>
          </a:xfrm>
        </p:grpSpPr>
        <p:sp>
          <p:nvSpPr>
            <p:cNvPr id="68" name="直接连接符 37"/>
            <p:cNvSpPr/>
            <p:nvPr/>
          </p:nvSpPr>
          <p:spPr>
            <a:xfrm>
              <a:off x="3165480" y="2072160"/>
              <a:ext cx="337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右箭头 1"/>
            <p:cNvSpPr/>
            <p:nvPr/>
          </p:nvSpPr>
          <p:spPr>
            <a:xfrm>
              <a:off x="755640" y="1727280"/>
              <a:ext cx="1334880" cy="712800"/>
            </a:xfrm>
            <a:prstGeom prst="rightArrow">
              <a:avLst>
                <a:gd name="adj1" fmla="val 50000"/>
                <a:gd name="adj2" fmla="val 56667"/>
              </a:avLst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矩形 3"/>
            <p:cNvSpPr/>
            <p:nvPr/>
          </p:nvSpPr>
          <p:spPr>
            <a:xfrm>
              <a:off x="2443320" y="1855800"/>
              <a:ext cx="744840" cy="43668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接连接符 5"/>
            <p:cNvSpPr/>
            <p:nvPr/>
          </p:nvSpPr>
          <p:spPr>
            <a:xfrm>
              <a:off x="2106000" y="2072160"/>
              <a:ext cx="337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文本框 6"/>
            <p:cNvSpPr/>
            <p:nvPr/>
          </p:nvSpPr>
          <p:spPr>
            <a:xfrm>
              <a:off x="761400" y="1956600"/>
              <a:ext cx="1208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T7 promoter 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文本框 63"/>
            <p:cNvSpPr/>
            <p:nvPr/>
          </p:nvSpPr>
          <p:spPr>
            <a:xfrm>
              <a:off x="2466360" y="1924200"/>
              <a:ext cx="757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6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× His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矩形 39"/>
            <p:cNvSpPr/>
            <p:nvPr/>
          </p:nvSpPr>
          <p:spPr>
            <a:xfrm>
              <a:off x="4305960" y="1849680"/>
              <a:ext cx="1812600" cy="43236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矩形 40"/>
            <p:cNvSpPr/>
            <p:nvPr/>
          </p:nvSpPr>
          <p:spPr>
            <a:xfrm>
              <a:off x="6445440" y="1859040"/>
              <a:ext cx="658080" cy="43236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接连接符 41"/>
            <p:cNvSpPr/>
            <p:nvPr/>
          </p:nvSpPr>
          <p:spPr>
            <a:xfrm>
              <a:off x="6118560" y="2075760"/>
              <a:ext cx="337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矩形 43"/>
            <p:cNvSpPr/>
            <p:nvPr/>
          </p:nvSpPr>
          <p:spPr>
            <a:xfrm>
              <a:off x="7303320" y="1863000"/>
              <a:ext cx="505800" cy="43236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文本框 68"/>
            <p:cNvSpPr/>
            <p:nvPr/>
          </p:nvSpPr>
          <p:spPr>
            <a:xfrm>
              <a:off x="4935960" y="1871280"/>
              <a:ext cx="87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MsrA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文本框 69"/>
            <p:cNvSpPr/>
            <p:nvPr/>
          </p:nvSpPr>
          <p:spPr>
            <a:xfrm>
              <a:off x="6445440" y="1924200"/>
              <a:ext cx="713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Hind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III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文本框 71"/>
            <p:cNvSpPr/>
            <p:nvPr/>
          </p:nvSpPr>
          <p:spPr>
            <a:xfrm>
              <a:off x="7344360" y="1924200"/>
              <a:ext cx="46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End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文本框 65"/>
            <p:cNvSpPr/>
            <p:nvPr/>
          </p:nvSpPr>
          <p:spPr>
            <a:xfrm>
              <a:off x="3492360" y="1871280"/>
              <a:ext cx="742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 Narrow"/>
                </a:rPr>
                <a:t>BamH</a:t>
              </a:r>
              <a:r>
                <a:rPr b="0" lang="az-Cyrl-AZ" sz="1400" spc="-1" strike="noStrike">
                  <a:solidFill>
                    <a:srgbClr val="000000"/>
                  </a:solidFill>
                  <a:latin typeface="Arial Narrow"/>
                  <a:ea typeface="Times New Roman"/>
                </a:rPr>
                <a:t>І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矩形 38"/>
            <p:cNvSpPr/>
            <p:nvPr/>
          </p:nvSpPr>
          <p:spPr>
            <a:xfrm>
              <a:off x="3503880" y="1863000"/>
              <a:ext cx="618480" cy="4248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直接连接符 42"/>
            <p:cNvSpPr/>
            <p:nvPr/>
          </p:nvSpPr>
          <p:spPr>
            <a:xfrm>
              <a:off x="4118760" y="2069280"/>
              <a:ext cx="202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接连接符 42"/>
            <p:cNvSpPr/>
            <p:nvPr/>
          </p:nvSpPr>
          <p:spPr>
            <a:xfrm>
              <a:off x="7099200" y="2069280"/>
              <a:ext cx="202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Administrator</dc:creator>
  <dc:description/>
  <cp:keywords/>
  <dc:language>en-US</dc:language>
  <cp:lastModifiedBy>Fen Du</cp:lastModifiedBy>
  <dcterms:modified xsi:type="dcterms:W3CDTF">2015-09-18T03:40:34Z</dcterms:modified>
  <cp:revision>257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866</vt:lpwstr>
  </property>
</Properties>
</file>